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43" d="100"/>
          <a:sy n="143" d="100"/>
        </p:scale>
        <p:origin x="-112" y="-3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0980869578080449"/>
          <c:y val="0.146627144169787"/>
          <c:w val="0.848277596364"/>
          <c:h val="0.77385785310260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J$10</c:f>
              <c:strCache>
                <c:ptCount val="1"/>
                <c:pt idx="0">
                  <c:v>Area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/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I$11:$I$16</c:f>
              <c:numCache>
                <c:formatCode>General</c:formatCode>
                <c:ptCount val="6"/>
                <c:pt idx="0">
                  <c:v>50.0</c:v>
                </c:pt>
                <c:pt idx="1">
                  <c:v>80.0</c:v>
                </c:pt>
                <c:pt idx="2">
                  <c:v>110.0</c:v>
                </c:pt>
                <c:pt idx="3">
                  <c:v>140.0</c:v>
                </c:pt>
                <c:pt idx="4">
                  <c:v>170.0</c:v>
                </c:pt>
                <c:pt idx="5">
                  <c:v>200.0</c:v>
                </c:pt>
              </c:numCache>
            </c:numRef>
          </c:xVal>
          <c:yVal>
            <c:numRef>
              <c:f>Sheet1!$J$11:$J$16</c:f>
              <c:numCache>
                <c:formatCode>General</c:formatCode>
                <c:ptCount val="6"/>
                <c:pt idx="0">
                  <c:v>2.996056E6</c:v>
                </c:pt>
                <c:pt idx="1">
                  <c:v>4.309645E6</c:v>
                </c:pt>
                <c:pt idx="2">
                  <c:v>5.288683E6</c:v>
                </c:pt>
                <c:pt idx="3">
                  <c:v>5.773724E6</c:v>
                </c:pt>
                <c:pt idx="4">
                  <c:v>7.219107E6</c:v>
                </c:pt>
                <c:pt idx="5">
                  <c:v>7.884704E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0931304"/>
        <c:axId val="2140686360"/>
      </c:scatterChart>
      <c:valAx>
        <c:axId val="21409313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0686360"/>
        <c:crosses val="autoZero"/>
        <c:crossBetween val="midCat"/>
      </c:valAx>
      <c:valAx>
        <c:axId val="2140686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09313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19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627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475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6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33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610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08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613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541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59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223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D143D-AC42-454C-8276-97534BF34C10}" type="datetimeFigureOut">
              <a:rPr lang="en-US" smtClean="0"/>
              <a:t>01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4EA34-DBF5-4F92-BE8B-CB1D68C7CF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160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4019524465"/>
              </p:ext>
            </p:extLst>
          </p:nvPr>
        </p:nvGraphicFramePr>
        <p:xfrm>
          <a:off x="6052922" y="366356"/>
          <a:ext cx="4579725" cy="31878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314" name="Rectangle 6"/>
          <p:cNvSpPr>
            <a:spLocks noChangeArrowheads="1"/>
          </p:cNvSpPr>
          <p:nvPr/>
        </p:nvSpPr>
        <p:spPr bwMode="auto">
          <a:xfrm>
            <a:off x="358775" y="5311775"/>
            <a:ext cx="13501688" cy="160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600" dirty="0">
              <a:solidFill>
                <a:srgbClr val="111111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6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dditional file 5: Figure showing quantification </a:t>
            </a:r>
            <a:r>
              <a:rPr lang="en-US" sz="1200" b="1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of </a:t>
            </a:r>
            <a:r>
              <a:rPr lang="en-US" sz="1200" b="1" dirty="0" smtClean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zelaic </a:t>
            </a:r>
            <a:r>
              <a:rPr lang="en-US" sz="1200" b="1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cid by HPLC on C18 reverse phase column</a:t>
            </a: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Quantification of azelaic acid  (PSA produced) by standard curve A&amp;B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endParaRPr lang="en-US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13315" name="Rectangle 7"/>
          <p:cNvSpPr>
            <a:spLocks noChangeArrowheads="1"/>
          </p:cNvSpPr>
          <p:nvPr/>
        </p:nvSpPr>
        <p:spPr bwMode="auto">
          <a:xfrm>
            <a:off x="488950" y="3317875"/>
            <a:ext cx="10291763" cy="2959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x = (y-b)/m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y= Area of test sample 4295132</a:t>
            </a: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=2E+06</a:t>
            </a: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=32054</a:t>
            </a: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X= (4295132-2E+06)/32054</a:t>
            </a: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=71.60 in 25µl</a:t>
            </a:r>
            <a:endParaRPr lang="en-US" sz="1200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=2.8 µg/µl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otal volume of the sample is 50µl (extracted and reconstituted from a 4 liter culture).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otal concentration in the 50µl sample was extrapolated to be 143.2 µg. Since the sample was purified from a 4 </a:t>
            </a:r>
            <a:r>
              <a:rPr lang="en-US" sz="1200" dirty="0" err="1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litre</a:t>
            </a:r>
            <a:r>
              <a:rPr lang="en-US" sz="1200" dirty="0">
                <a:solidFill>
                  <a:srgbClr val="111111"/>
                </a:solidFill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of culture, it corresponds to 36µg/L.</a:t>
            </a:r>
            <a:endParaRPr lang="en-US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200" dirty="0">
              <a:solidFill>
                <a:srgbClr val="111111"/>
              </a:solidFill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13316" name="TextBox 8"/>
          <p:cNvSpPr txBox="1">
            <a:spLocks noChangeArrowheads="1"/>
          </p:cNvSpPr>
          <p:nvPr/>
        </p:nvSpPr>
        <p:spPr bwMode="auto">
          <a:xfrm>
            <a:off x="160338" y="173038"/>
            <a:ext cx="1984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3317" name="TextBox 11"/>
          <p:cNvSpPr txBox="1">
            <a:spLocks noChangeArrowheads="1"/>
          </p:cNvSpPr>
          <p:nvPr/>
        </p:nvSpPr>
        <p:spPr bwMode="auto">
          <a:xfrm>
            <a:off x="6053138" y="293688"/>
            <a:ext cx="196850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graphicFrame>
        <p:nvGraphicFramePr>
          <p:cNvPr id="10" name="Table 9"/>
          <p:cNvGraphicFramePr>
            <a:graphicFrameLocks noGrp="1"/>
          </p:cNvGraphicFramePr>
          <p:nvPr/>
        </p:nvGraphicFramePr>
        <p:xfrm>
          <a:off x="879475" y="366713"/>
          <a:ext cx="2579370" cy="2557802"/>
        </p:xfrm>
        <a:graphic>
          <a:graphicData uri="http://schemas.openxmlformats.org/drawingml/2006/table">
            <a:tbl>
              <a:tblPr firstRow="1" firstCol="1" bandRow="1"/>
              <a:tblGrid>
                <a:gridCol w="1289685"/>
                <a:gridCol w="1289685"/>
              </a:tblGrid>
              <a:tr h="77533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ample in µ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re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306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9605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0964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8868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77372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765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1910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8470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2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Test sample 25ul 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9513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50531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1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ICGEB ICGEB</cp:lastModifiedBy>
  <cp:revision>5</cp:revision>
  <dcterms:created xsi:type="dcterms:W3CDTF">2017-06-03T12:12:18Z</dcterms:created>
  <dcterms:modified xsi:type="dcterms:W3CDTF">2018-11-01T10:17:29Z</dcterms:modified>
</cp:coreProperties>
</file>